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36F603D-876B-4CA6-AEB7-EE7A77550C11}" name="ayuroom@gmail.com" initials="a" userId="52db80baf4e9c447" providerId="Windows Live"/>
  <p188:author id="{B29860B3-B00F-258F-49FB-67F16C19EDE4}" name="山田 康隆" initials="山田" userId="28c459bdc7e79643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279" autoAdjust="0"/>
  </p:normalViewPr>
  <p:slideViewPr>
    <p:cSldViewPr snapToGrid="0">
      <p:cViewPr varScale="1">
        <p:scale>
          <a:sx n="56" d="100"/>
          <a:sy n="56" d="100"/>
        </p:scale>
        <p:origin x="76" y="1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170498-B31E-0713-17F2-D8D8678141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F0338BB-5078-DC55-A574-76BC598E6E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C2E77C-3657-CB56-F0D0-06F78EAF8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1A993C-D0A6-334D-5AD3-BEF4F2086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B710AD-8BDD-34C8-9E97-A2BD74C95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265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2ADE24-E927-822A-48EA-957256F517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2B20B36-37F7-44EB-6B91-3ADCD17E45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6845DC-A41B-A15B-64E4-ECAA24BAA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94F506-0537-3CDF-9D89-B7A678D85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0937B02-8517-B101-A74B-ED77F4537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4048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74632F4-DE0C-5847-D402-DB8F872E9C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C2EAED3-C8D3-8BB6-B687-E9C3577FC9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64122E-D3AF-A94E-08A0-16F42BE94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F7E706-EAC5-35B1-C40B-7C122E49C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7A57DD-3FEE-0A01-8C6B-758E435B5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41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340177-AA1A-DC5A-231A-FACE849019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F0C794-2503-0A6B-0028-CBB6001DDE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741176-CAD2-CB83-3806-25A54345D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90B83D-17E1-FA28-5BEF-866E8D1F4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E7B552-F024-C8CC-848B-C08CFF0F9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056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FCC35C-D17A-0E1A-3E28-4A2ADE64F8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A8F0081-8BD9-96BB-B490-1661C938A4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FDF49B-0A88-C56F-D738-9FE676289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C7F987-E6F0-D676-B411-BECA1C5CF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84DBBF-5891-F33F-213B-BFC2D7DF8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103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2B68F09-884F-B6A3-9AF7-E1916EDE5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8370B64-5F4C-E989-53DF-1E2FFDE47D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51AEDF5-E1CF-75EC-BAA7-76D4A27FAD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7B09137-67FA-ACCF-6C5F-96A24F0AA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4D9C0B1-91A7-B98C-D8B4-E536C46C9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009549-037A-5B49-4956-BAF32999E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557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23AE07-28F4-E4C7-1985-82D174216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03449E-879B-D892-EB75-FE3056188D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68EE1CC-3236-4F5F-8FB1-28DFC3DBFF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FB7729E-DC85-3D00-0287-531E9C4C07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F610D42-46D3-80E7-56E4-4E15762398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68A617D-1074-F0DB-4630-4E8CEB964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BA3B58D-467C-6E27-6610-09A40E41B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62CA9CB-E953-456E-4F3B-4D957C1BE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093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2FD64A-41B9-FB1D-BDDA-3957911922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5C1F97A-E9D5-86EE-3866-F6A8267AB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9E0CCD5-91B7-8718-9EDC-6E209D8DF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E00C726-3507-07ED-61D3-85CFBBE04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4511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91DB8E4-803F-7774-AD10-29EBA90C1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9483103-443B-7F9A-6292-47FCC73AC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D78BC74-9E09-D040-A3AF-F6527F44D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429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83F1EE-0D25-27A1-C674-2E9695538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BB0C02B-11E5-E7BC-1783-DE9B450CC5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3E516F2-E6AF-E7DC-161A-0C260D0791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9503C1C-830F-88B1-F7B5-5B972716B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52C371C-3FB1-2259-904C-D1FB99460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022565-063F-CA85-AA1F-09762C767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378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9C2F21-6AAA-D0B1-FF0D-DD3A0DB9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DBD92FE-D70B-FDFD-FA95-321E932C3B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85DA590-6C73-368A-4DEF-24B2F2F577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6E1550-E682-EFF5-A9E9-64C3A8C6D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0C9CAA-26AF-C093-45E8-3F48321FB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0E71DC-B415-5279-6EAA-E6986889A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9710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AA2E897-2EEC-B3D2-E4ED-65821388BF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CC105C-D556-6818-3E2A-DDCB0B4E4D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E6820F-8F1E-E1FA-A09B-E1CFD79A6C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509C1-336F-4321-9E3B-F3B4DA48541F}" type="datetimeFigureOut">
              <a:rPr kumimoji="1" lang="ja-JP" altLang="en-US" smtClean="0"/>
              <a:t>2023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DE93F5-AF37-BF8F-BB7B-28129D119A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208AD3-5AB0-25CD-4662-E72F049C91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7BEC9-0F2E-4655-9A18-177C6D2AEA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2834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3112C6-03B9-310F-B5E7-CBE3BD59ED7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ja-JP" sz="3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umor localization by Prostate Imaging and Reporting and Data System (PI-RADS) version 2.1 predicts prognosis of prostate cancer after radical prostatectomy</a:t>
            </a:r>
            <a:br>
              <a:rPr lang="ja-JP" altLang="ja-JP" sz="320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rPr>
            </a:b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5115297-B186-75BD-49D7-7869775EA76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34651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7A99494A-E232-7F6A-393F-2FFAD0DD0B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8677035"/>
              </p:ext>
            </p:extLst>
          </p:nvPr>
        </p:nvGraphicFramePr>
        <p:xfrm>
          <a:off x="386080" y="272574"/>
          <a:ext cx="5534661" cy="4962371"/>
        </p:xfrm>
        <a:graphic>
          <a:graphicData uri="http://schemas.openxmlformats.org/drawingml/2006/table">
            <a:tbl>
              <a:tblPr/>
              <a:tblGrid>
                <a:gridCol w="1737796">
                  <a:extLst>
                    <a:ext uri="{9D8B030D-6E8A-4147-A177-3AD203B41FA5}">
                      <a16:colId xmlns:a16="http://schemas.microsoft.com/office/drawing/2014/main" val="3942282218"/>
                    </a:ext>
                  </a:extLst>
                </a:gridCol>
                <a:gridCol w="1781606">
                  <a:extLst>
                    <a:ext uri="{9D8B030D-6E8A-4147-A177-3AD203B41FA5}">
                      <a16:colId xmlns:a16="http://schemas.microsoft.com/office/drawing/2014/main" val="3855253734"/>
                    </a:ext>
                  </a:extLst>
                </a:gridCol>
                <a:gridCol w="759373">
                  <a:extLst>
                    <a:ext uri="{9D8B030D-6E8A-4147-A177-3AD203B41FA5}">
                      <a16:colId xmlns:a16="http://schemas.microsoft.com/office/drawing/2014/main" val="3370100028"/>
                    </a:ext>
                  </a:extLst>
                </a:gridCol>
                <a:gridCol w="1255886">
                  <a:extLst>
                    <a:ext uri="{9D8B030D-6E8A-4147-A177-3AD203B41FA5}">
                      <a16:colId xmlns:a16="http://schemas.microsoft.com/office/drawing/2014/main" val="3230248605"/>
                    </a:ext>
                  </a:extLst>
                </a:gridCol>
              </a:tblGrid>
              <a:tr h="471763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ja-JP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upplementary Table 1. Change in category following change in evaluation criteria from PI-RADS v2.0 to PI-RADS v2.1 (n=40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2757014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l" fontAlgn="ctr"/>
                      <a:r>
                        <a:rPr lang="ja-JP" sz="1300" b="0" i="0" u="none" strike="noStrike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游明朝" panose="02020400000000000000" pitchFamily="18" charset="-128"/>
                        </a:rPr>
                        <a:t>　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Z 2→1 Grade-down (%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Z 2→3 Grade-up (%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6365038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57031793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CR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 (12.9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2023941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thological location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9695395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Z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 (100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 (48.3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9385067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Z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(6.5)</a:t>
                      </a:r>
                      <a:endParaRPr 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3894495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Z &amp; PZ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0 (32.3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9415539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Z &amp; PZ &amp; CZ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(6.5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1230948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Z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(3.2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2001965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Z &amp; PZ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(3.2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5673308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leason pattern with 5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(11.1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 (9.7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5560218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athological Grade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412732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+3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 (33.3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 (22.6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3704744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+4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 (44.4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6 (51.5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605672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+3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(22.3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 (9.7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2337100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+4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(6.5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8630032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+5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 (3.2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6635194"/>
                  </a:ext>
                </a:extLst>
              </a:tr>
              <a:tr h="22541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+4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sz="1300" b="0" i="0" u="none" strike="noStrike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游明朝" panose="02020400000000000000" pitchFamily="18" charset="-128"/>
                        </a:rPr>
                        <a:t>　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3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 (6.5)</a:t>
                      </a:r>
                      <a:endParaRPr lang="ja-JP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1239329"/>
                  </a:ext>
                </a:extLst>
              </a:tr>
              <a:tr h="433120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bbreviations: PI-RADS: Prostate Reporting and Imaging and Data System; BCR: biochemical recurrence; TZ: transition zone; PZ: peripheral zone; CZ: central zone.</a:t>
                      </a:r>
                      <a:endParaRPr lang="ja-JP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71803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02169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7</TotalTime>
  <Words>209</Words>
  <Application>Microsoft Office PowerPoint</Application>
  <PresentationFormat>ワイド画面</PresentationFormat>
  <Paragraphs>4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Tumor localization by Prostate Imaging and Reporting and Data System (PI-RADS) version 2.1 predicts prognosis of prostate cancer after radical prostatectomy 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yuroom@gmail.com</dc:creator>
  <cp:lastModifiedBy>ayuroom@gmail.com</cp:lastModifiedBy>
  <cp:revision>69</cp:revision>
  <dcterms:created xsi:type="dcterms:W3CDTF">2022-10-05T03:29:19Z</dcterms:created>
  <dcterms:modified xsi:type="dcterms:W3CDTF">2023-05-18T00:45:33Z</dcterms:modified>
</cp:coreProperties>
</file>